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5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7" d="100"/>
          <a:sy n="77" d="100"/>
        </p:scale>
        <p:origin x="313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F2868-6A84-47B6-A624-533D6C3F7CB3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C9EF8-E2AC-498C-BD12-66BB4AE40B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9308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F2868-6A84-47B6-A624-533D6C3F7CB3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C9EF8-E2AC-498C-BD12-66BB4AE40B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40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F2868-6A84-47B6-A624-533D6C3F7CB3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C9EF8-E2AC-498C-BD12-66BB4AE40B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2663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F2868-6A84-47B6-A624-533D6C3F7CB3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C9EF8-E2AC-498C-BD12-66BB4AE40B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11074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F2868-6A84-47B6-A624-533D6C3F7CB3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C9EF8-E2AC-498C-BD12-66BB4AE40B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3916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F2868-6A84-47B6-A624-533D6C3F7CB3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C9EF8-E2AC-498C-BD12-66BB4AE40B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4684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F2868-6A84-47B6-A624-533D6C3F7CB3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C9EF8-E2AC-498C-BD12-66BB4AE40B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59044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F2868-6A84-47B6-A624-533D6C3F7CB3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C9EF8-E2AC-498C-BD12-66BB4AE40B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32536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F2868-6A84-47B6-A624-533D6C3F7CB3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C9EF8-E2AC-498C-BD12-66BB4AE40B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30668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F2868-6A84-47B6-A624-533D6C3F7CB3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C9EF8-E2AC-498C-BD12-66BB4AE40B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80606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6CF2868-6A84-47B6-A624-533D6C3F7CB3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5C9EF8-E2AC-498C-BD12-66BB4AE40B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641713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CF2868-6A84-47B6-A624-533D6C3F7CB3}" type="datetimeFigureOut">
              <a:rPr lang="en-GB" smtClean="0"/>
              <a:t>24/08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5C9EF8-E2AC-498C-BD12-66BB4AE40BD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53254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71AC0F-B13D-E65D-5AE6-A2670BF8F9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GB" sz="2000" b="1" dirty="0"/>
              <a:t>Standard operating procedure for the preparation of intravitreal rhTPP-1 from </a:t>
            </a:r>
            <a:r>
              <a:rPr lang="en-GB" sz="2000" b="1" dirty="0" err="1"/>
              <a:t>Brineura</a:t>
            </a:r>
            <a:r>
              <a:rPr lang="en-GB" sz="2000" b="1" dirty="0"/>
              <a:t> overag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DEDFC5E-410B-09A4-F66D-E19A7BDD4C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71487" y="2656238"/>
            <a:ext cx="5915025" cy="6285266"/>
          </a:xfrm>
        </p:spPr>
        <p:txBody>
          <a:bodyPr>
            <a:normAutofit/>
          </a:bodyPr>
          <a:lstStyle/>
          <a:p>
            <a:pPr marL="0" indent="0" algn="just">
              <a:buNone/>
            </a:pPr>
            <a:r>
              <a:rPr lang="en-US" sz="1600" dirty="0">
                <a:latin typeface="+mj-lt"/>
              </a:rPr>
              <a:t>The </a:t>
            </a:r>
            <a:r>
              <a:rPr lang="en-US" sz="1600" dirty="0" err="1">
                <a:latin typeface="+mj-lt"/>
              </a:rPr>
              <a:t>Cerliponase</a:t>
            </a:r>
            <a:r>
              <a:rPr lang="en-US" sz="1600" dirty="0">
                <a:latin typeface="+mj-lt"/>
              </a:rPr>
              <a:t> alfa (</a:t>
            </a:r>
            <a:r>
              <a:rPr lang="en-US" sz="1600" dirty="0" err="1">
                <a:latin typeface="+mj-lt"/>
              </a:rPr>
              <a:t>Brineura</a:t>
            </a:r>
            <a:r>
              <a:rPr lang="en-US" sz="1600" dirty="0">
                <a:latin typeface="+mj-lt"/>
              </a:rPr>
              <a:t> ®) vial contains a 150mg in 5mL solution for infusion, for intracerebroventricular use. Vials are stored at -25°C to -15°C.</a:t>
            </a:r>
          </a:p>
          <a:p>
            <a:pPr marL="0" indent="0" algn="just">
              <a:buNone/>
            </a:pPr>
            <a:r>
              <a:rPr lang="en-US" sz="1600" dirty="0">
                <a:latin typeface="+mj-lt"/>
              </a:rPr>
              <a:t>The preparation of intravitreal (IVT) doses was carried out in the Great </a:t>
            </a:r>
            <a:r>
              <a:rPr lang="en-US" sz="1600" dirty="0" err="1">
                <a:latin typeface="+mj-lt"/>
              </a:rPr>
              <a:t>Ormonds</a:t>
            </a:r>
            <a:r>
              <a:rPr lang="en-US" sz="1600" dirty="0">
                <a:latin typeface="+mj-lt"/>
              </a:rPr>
              <a:t> Street Hospital Pharmacy Central Intravenous Additive Service (CIVAS) sterile unit. </a:t>
            </a:r>
          </a:p>
          <a:p>
            <a:pPr marL="0" indent="0" algn="just">
              <a:buNone/>
            </a:pPr>
            <a:r>
              <a:rPr lang="en-US" sz="1600" dirty="0">
                <a:latin typeface="+mj-lt"/>
              </a:rPr>
              <a:t>The frozen vials were left to thaw for 60 minutes. A 0.2mL solution containing 6mg of </a:t>
            </a:r>
            <a:r>
              <a:rPr lang="en-US" sz="1600" dirty="0" err="1">
                <a:latin typeface="+mj-lt"/>
              </a:rPr>
              <a:t>Cerliponase</a:t>
            </a:r>
            <a:r>
              <a:rPr lang="en-US" sz="1600" dirty="0">
                <a:latin typeface="+mj-lt"/>
              </a:rPr>
              <a:t> alfa was added to 1.3mL of Sterile Irrigating Solution or Balanced Salt Solution (BSS), Alcon Laboratories Ltd. This resulted in a solution containing 6mg of </a:t>
            </a:r>
            <a:r>
              <a:rPr lang="en-US" sz="1600" dirty="0" err="1">
                <a:latin typeface="+mj-lt"/>
              </a:rPr>
              <a:t>Cerliponase</a:t>
            </a:r>
            <a:r>
              <a:rPr lang="en-US" sz="1600" dirty="0">
                <a:latin typeface="+mj-lt"/>
              </a:rPr>
              <a:t> alfa in 1.5mL. </a:t>
            </a:r>
          </a:p>
          <a:p>
            <a:pPr marL="0" indent="0" algn="just">
              <a:buNone/>
            </a:pPr>
            <a:r>
              <a:rPr lang="en-US" sz="1600" dirty="0">
                <a:latin typeface="+mj-lt"/>
              </a:rPr>
              <a:t>The resulting solution was passed through a 0.2 micron filter into a 1ml syringe suitable for intravitreal injection. Once prepared, the IVT dose can be stored at room temperature with a 4 hours expiry. An intravitreal injection of 0.05mL of this solution was used to deliver a dose of 0.2mg rhTPP-1 in in 0.05mL BSS. </a:t>
            </a:r>
            <a:endParaRPr lang="en-GB" sz="1600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3513915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76</TotalTime>
  <Words>184</Words>
  <Application>Microsoft Office PowerPoint</Application>
  <PresentationFormat>A4 Paper (210x297 mm)</PresentationFormat>
  <Paragraphs>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tandard operating procedure for the preparation of intravitreal rhTPP-1 from Brineura overag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mes Wawrzynski</dc:creator>
  <cp:lastModifiedBy>Wawrzynski, James</cp:lastModifiedBy>
  <cp:revision>45</cp:revision>
  <cp:lastPrinted>2023-04-18T19:46:57Z</cp:lastPrinted>
  <dcterms:created xsi:type="dcterms:W3CDTF">2023-02-24T15:43:26Z</dcterms:created>
  <dcterms:modified xsi:type="dcterms:W3CDTF">2023-08-24T21:43:16Z</dcterms:modified>
</cp:coreProperties>
</file>